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138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9709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326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7636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8845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8480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303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5741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305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8404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836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708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45BA4-0AF3-44B8-A29F-ECC645997047}" type="datetimeFigureOut">
              <a:rPr lang="zh-CN" altLang="en-US" smtClean="0"/>
              <a:t>2016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A65A5-5F6F-4854-B837-171AD5F95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099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496" y="76562"/>
            <a:ext cx="34765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ure e-1</a:t>
            </a:r>
            <a:endParaRPr lang="zh-CN" altLang="en-US" sz="2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789038" y="3429000"/>
            <a:ext cx="5904656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etection stability of the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Ch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levels in PBMCs.</a:t>
            </a:r>
          </a:p>
          <a:p>
            <a:pPr>
              <a:lnSpc>
                <a:spcPct val="200000"/>
              </a:lnSpc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ACh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levels were not changed in PBMCs after pre-adding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eserin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a cholinesterase inhibitor, to the peripheral blood sample 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 = 4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 each group) (</a:t>
            </a:r>
            <a:r>
              <a:rPr lang="en-US" altLang="zh-CN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= 0.8857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 levels of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ACh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in PBMCs were not significantly different between untreated and treated MG patients with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yridostigmin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 = 8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 each group) (</a:t>
            </a:r>
            <a:r>
              <a:rPr lang="en-US" altLang="zh-CN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= 0.9768)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8276" y="1067346"/>
            <a:ext cx="5596128" cy="2676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60502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7</TotalTime>
  <Words>78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Office 主题</vt:lpstr>
      <vt:lpstr>GraphPad Prism 5 Project</vt:lpstr>
      <vt:lpstr>Prism Project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b</dc:creator>
  <cp:lastModifiedBy>USER-</cp:lastModifiedBy>
  <cp:revision>42</cp:revision>
  <dcterms:created xsi:type="dcterms:W3CDTF">2016-01-17T14:10:57Z</dcterms:created>
  <dcterms:modified xsi:type="dcterms:W3CDTF">2016-12-30T14:55:11Z</dcterms:modified>
</cp:coreProperties>
</file>